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61"/>
    <p:restoredTop sz="94718"/>
  </p:normalViewPr>
  <p:slideViewPr>
    <p:cSldViewPr snapToGrid="0" snapToObjects="1" showGuides="1">
      <p:cViewPr>
        <p:scale>
          <a:sx n="120" d="100"/>
          <a:sy n="120" d="100"/>
        </p:scale>
        <p:origin x="1712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764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072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247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285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230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194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82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92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519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938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47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D4245-AC37-3D49-8C43-6E694C91B64B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24F17-37C2-A745-A2F1-8BC19642C8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630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>
            <a:extLst>
              <a:ext uri="{FF2B5EF4-FFF2-40B4-BE49-F238E27FC236}">
                <a16:creationId xmlns:a16="http://schemas.microsoft.com/office/drawing/2014/main" id="{AF33751B-1D47-474D-AA2E-6941886B508B}"/>
              </a:ext>
            </a:extLst>
          </p:cNvPr>
          <p:cNvGrpSpPr/>
          <p:nvPr/>
        </p:nvGrpSpPr>
        <p:grpSpPr>
          <a:xfrm>
            <a:off x="1033859" y="953730"/>
            <a:ext cx="4790282" cy="2505802"/>
            <a:chOff x="-352303" y="2602211"/>
            <a:chExt cx="7472830" cy="385615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B0717C3-BA43-6141-A3B2-02139A228B5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352303" y="3073820"/>
              <a:ext cx="3714750" cy="338455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E443069-CB9A-4648-8065-CA2BCFFCFC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321" b="2717"/>
            <a:stretch/>
          </p:blipFill>
          <p:spPr>
            <a:xfrm>
              <a:off x="3555069" y="3073820"/>
              <a:ext cx="3540271" cy="3384550"/>
            </a:xfrm>
            <a:prstGeom prst="rect">
              <a:avLst/>
            </a:prstGeom>
          </p:spPr>
        </p:pic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D1B07C2E-D4B2-BD47-9CD4-F3ED28AC1E82}"/>
                </a:ext>
              </a:extLst>
            </p:cNvPr>
            <p:cNvGrpSpPr/>
            <p:nvPr/>
          </p:nvGrpSpPr>
          <p:grpSpPr>
            <a:xfrm>
              <a:off x="6040910" y="3147312"/>
              <a:ext cx="1079617" cy="2871881"/>
              <a:chOff x="8506995" y="1762209"/>
              <a:chExt cx="996569" cy="2650965"/>
            </a:xfrm>
          </p:grpSpPr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D74AD94E-BD73-9E4C-947E-1D0429F3ECE9}"/>
                  </a:ext>
                </a:extLst>
              </p:cNvPr>
              <p:cNvCxnSpPr/>
              <p:nvPr/>
            </p:nvCxnSpPr>
            <p:spPr>
              <a:xfrm>
                <a:off x="8506995" y="2708695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2624B333-3530-424D-823E-45C79649F2C0}"/>
                  </a:ext>
                </a:extLst>
              </p:cNvPr>
              <p:cNvCxnSpPr/>
              <p:nvPr/>
            </p:nvCxnSpPr>
            <p:spPr>
              <a:xfrm>
                <a:off x="8506995" y="3068130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904D6CA7-5A97-1645-95AF-CDFCAD4B9590}"/>
                  </a:ext>
                </a:extLst>
              </p:cNvPr>
              <p:cNvCxnSpPr/>
              <p:nvPr/>
            </p:nvCxnSpPr>
            <p:spPr>
              <a:xfrm>
                <a:off x="8506995" y="3462071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84897559-D9B5-604C-AF40-AA059B2A7793}"/>
                  </a:ext>
                </a:extLst>
              </p:cNvPr>
              <p:cNvCxnSpPr/>
              <p:nvPr/>
            </p:nvCxnSpPr>
            <p:spPr>
              <a:xfrm>
                <a:off x="8506995" y="3717989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6563CD6E-019C-9B43-A79C-B855E958DA42}"/>
                  </a:ext>
                </a:extLst>
              </p:cNvPr>
              <p:cNvCxnSpPr/>
              <p:nvPr/>
            </p:nvCxnSpPr>
            <p:spPr>
              <a:xfrm>
                <a:off x="8506995" y="4008413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39456A3F-F322-A540-BF3D-A48382D7E5DD}"/>
                  </a:ext>
                </a:extLst>
              </p:cNvPr>
              <p:cNvCxnSpPr/>
              <p:nvPr/>
            </p:nvCxnSpPr>
            <p:spPr>
              <a:xfrm>
                <a:off x="8506995" y="4333342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62D8C8AC-4A4B-AE49-9F6C-D5310332901F}"/>
                  </a:ext>
                </a:extLst>
              </p:cNvPr>
              <p:cNvCxnSpPr/>
              <p:nvPr/>
            </p:nvCxnSpPr>
            <p:spPr>
              <a:xfrm>
                <a:off x="8506995" y="2208369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14340DD2-2E98-4540-A3A6-C353A24EE084}"/>
                  </a:ext>
                </a:extLst>
              </p:cNvPr>
              <p:cNvCxnSpPr/>
              <p:nvPr/>
            </p:nvCxnSpPr>
            <p:spPr>
              <a:xfrm>
                <a:off x="8506995" y="1946701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E00EF2F-9284-7944-AA69-A30B42273675}"/>
                  </a:ext>
                </a:extLst>
              </p:cNvPr>
              <p:cNvSpPr txBox="1"/>
              <p:nvPr/>
            </p:nvSpPr>
            <p:spPr>
              <a:xfrm>
                <a:off x="8955781" y="1762209"/>
                <a:ext cx="547783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D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6D46361-8BBA-F940-AFB4-259B18325686}"/>
                  </a:ext>
                </a:extLst>
              </p:cNvPr>
              <p:cNvSpPr txBox="1"/>
              <p:nvPr/>
            </p:nvSpPr>
            <p:spPr>
              <a:xfrm>
                <a:off x="8955783" y="2034776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5kD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918ED73-41D7-E443-82FF-27653470295F}"/>
                  </a:ext>
                </a:extLst>
              </p:cNvPr>
              <p:cNvSpPr txBox="1"/>
              <p:nvPr/>
            </p:nvSpPr>
            <p:spPr>
              <a:xfrm>
                <a:off x="8955783" y="2536315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C1F386B3-98DA-714B-8541-A4CD56C3D6D3}"/>
                  </a:ext>
                </a:extLst>
              </p:cNvPr>
              <p:cNvSpPr txBox="1"/>
              <p:nvPr/>
            </p:nvSpPr>
            <p:spPr>
              <a:xfrm>
                <a:off x="8955783" y="2911942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7kD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48521CD-BE80-AF45-A9CC-58E0C4EEE296}"/>
                  </a:ext>
                </a:extLst>
              </p:cNvPr>
              <p:cNvSpPr txBox="1"/>
              <p:nvPr/>
            </p:nvSpPr>
            <p:spPr>
              <a:xfrm>
                <a:off x="8955783" y="3302243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kD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1C70D70-DD07-494F-B886-D27E4B47C3A5}"/>
                  </a:ext>
                </a:extLst>
              </p:cNvPr>
              <p:cNvSpPr txBox="1"/>
              <p:nvPr/>
            </p:nvSpPr>
            <p:spPr>
              <a:xfrm>
                <a:off x="8955783" y="3574808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0kD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3C7D1C2-D02C-9048-8FB6-7E20A4BA6892}"/>
                  </a:ext>
                </a:extLst>
              </p:cNvPr>
              <p:cNvSpPr txBox="1"/>
              <p:nvPr/>
            </p:nvSpPr>
            <p:spPr>
              <a:xfrm>
                <a:off x="8955783" y="3847375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kD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B6075CE-2774-734B-AF81-EC2FEAC10AA5}"/>
                  </a:ext>
                </a:extLst>
              </p:cNvPr>
              <p:cNvSpPr txBox="1"/>
              <p:nvPr/>
            </p:nvSpPr>
            <p:spPr>
              <a:xfrm>
                <a:off x="8955783" y="4171688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kD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BA0B310-9237-DD4C-A6B7-8D6719550532}"/>
                </a:ext>
              </a:extLst>
            </p:cNvPr>
            <p:cNvGrpSpPr/>
            <p:nvPr/>
          </p:nvGrpSpPr>
          <p:grpSpPr>
            <a:xfrm>
              <a:off x="2131713" y="3147312"/>
              <a:ext cx="1079617" cy="2871881"/>
              <a:chOff x="8506995" y="1762209"/>
              <a:chExt cx="996569" cy="2650965"/>
            </a:xfrm>
          </p:grpSpPr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5E01F014-5241-FF4D-AB28-285AA6D1AA7D}"/>
                  </a:ext>
                </a:extLst>
              </p:cNvPr>
              <p:cNvCxnSpPr/>
              <p:nvPr/>
            </p:nvCxnSpPr>
            <p:spPr>
              <a:xfrm>
                <a:off x="8506995" y="2708695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119F7CE8-2165-344F-8752-0DB664CBAFA3}"/>
                  </a:ext>
                </a:extLst>
              </p:cNvPr>
              <p:cNvCxnSpPr/>
              <p:nvPr/>
            </p:nvCxnSpPr>
            <p:spPr>
              <a:xfrm>
                <a:off x="8506995" y="3068130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1486BA57-85BD-CE4D-A784-E423BC3F4CB4}"/>
                  </a:ext>
                </a:extLst>
              </p:cNvPr>
              <p:cNvCxnSpPr/>
              <p:nvPr/>
            </p:nvCxnSpPr>
            <p:spPr>
              <a:xfrm>
                <a:off x="8506995" y="3462071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C6C60C05-70B9-C14F-A23A-4FA35BF70BE2}"/>
                  </a:ext>
                </a:extLst>
              </p:cNvPr>
              <p:cNvCxnSpPr/>
              <p:nvPr/>
            </p:nvCxnSpPr>
            <p:spPr>
              <a:xfrm>
                <a:off x="8506995" y="3717989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27C30E96-4B22-844F-A182-AB1630A16D45}"/>
                  </a:ext>
                </a:extLst>
              </p:cNvPr>
              <p:cNvCxnSpPr/>
              <p:nvPr/>
            </p:nvCxnSpPr>
            <p:spPr>
              <a:xfrm>
                <a:off x="8506995" y="4008413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EF6D83CF-3112-4A4F-9C74-789718B9C559}"/>
                  </a:ext>
                </a:extLst>
              </p:cNvPr>
              <p:cNvCxnSpPr/>
              <p:nvPr/>
            </p:nvCxnSpPr>
            <p:spPr>
              <a:xfrm>
                <a:off x="8506995" y="4333342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5C143BC1-DEE2-0544-9C0E-81D5F160D0C5}"/>
                  </a:ext>
                </a:extLst>
              </p:cNvPr>
              <p:cNvCxnSpPr/>
              <p:nvPr/>
            </p:nvCxnSpPr>
            <p:spPr>
              <a:xfrm>
                <a:off x="8506995" y="2208369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995DC67E-1411-2C42-B52F-DECCAE498BA2}"/>
                  </a:ext>
                </a:extLst>
              </p:cNvPr>
              <p:cNvCxnSpPr/>
              <p:nvPr/>
            </p:nvCxnSpPr>
            <p:spPr>
              <a:xfrm>
                <a:off x="8506995" y="1946701"/>
                <a:ext cx="4572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C14100D-D790-E445-867F-067810E58ABC}"/>
                  </a:ext>
                </a:extLst>
              </p:cNvPr>
              <p:cNvSpPr txBox="1"/>
              <p:nvPr/>
            </p:nvSpPr>
            <p:spPr>
              <a:xfrm>
                <a:off x="8955781" y="1762209"/>
                <a:ext cx="547783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D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1DB3462-3954-5841-BC6D-8F7D4E991BBD}"/>
                  </a:ext>
                </a:extLst>
              </p:cNvPr>
              <p:cNvSpPr txBox="1"/>
              <p:nvPr/>
            </p:nvSpPr>
            <p:spPr>
              <a:xfrm>
                <a:off x="8955783" y="2034776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5kD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32EA9E23-78AA-C649-AACD-9FCC42DCF4F5}"/>
                  </a:ext>
                </a:extLst>
              </p:cNvPr>
              <p:cNvSpPr txBox="1"/>
              <p:nvPr/>
            </p:nvSpPr>
            <p:spPr>
              <a:xfrm>
                <a:off x="8955783" y="2536315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1EB7DCE5-1CF9-6E44-8B43-A74786A1E392}"/>
                  </a:ext>
                </a:extLst>
              </p:cNvPr>
              <p:cNvSpPr txBox="1"/>
              <p:nvPr/>
            </p:nvSpPr>
            <p:spPr>
              <a:xfrm>
                <a:off x="8955783" y="2911942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7kD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DC6CD8A-36B6-AC4B-A2E7-06C16B50B704}"/>
                  </a:ext>
                </a:extLst>
              </p:cNvPr>
              <p:cNvSpPr txBox="1"/>
              <p:nvPr/>
            </p:nvSpPr>
            <p:spPr>
              <a:xfrm>
                <a:off x="8955783" y="3302243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kD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013566CE-656C-734A-A9FF-985A37D843C1}"/>
                  </a:ext>
                </a:extLst>
              </p:cNvPr>
              <p:cNvSpPr txBox="1"/>
              <p:nvPr/>
            </p:nvSpPr>
            <p:spPr>
              <a:xfrm>
                <a:off x="8955783" y="3574808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0kD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60A3A4E-159B-9C4E-B4C4-FEED9C96464A}"/>
                  </a:ext>
                </a:extLst>
              </p:cNvPr>
              <p:cNvSpPr txBox="1"/>
              <p:nvPr/>
            </p:nvSpPr>
            <p:spPr>
              <a:xfrm>
                <a:off x="8955783" y="3847375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kD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192945F-3EC4-2446-B1E6-E8D4785A5FBE}"/>
                  </a:ext>
                </a:extLst>
              </p:cNvPr>
              <p:cNvSpPr txBox="1"/>
              <p:nvPr/>
            </p:nvSpPr>
            <p:spPr>
              <a:xfrm>
                <a:off x="8955783" y="4171688"/>
                <a:ext cx="475278" cy="241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kD</a:t>
                </a:r>
              </a:p>
            </p:txBody>
          </p: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49E58F4-849D-454E-BAF1-A9E1005861C4}"/>
                </a:ext>
              </a:extLst>
            </p:cNvPr>
            <p:cNvSpPr txBox="1"/>
            <p:nvPr/>
          </p:nvSpPr>
          <p:spPr>
            <a:xfrm>
              <a:off x="205684" y="2602211"/>
              <a:ext cx="28490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CRE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414E0E3-4F23-5C44-B68C-ED0EDE9C65A4}"/>
                </a:ext>
              </a:extLst>
            </p:cNvPr>
            <p:cNvSpPr txBox="1"/>
            <p:nvPr/>
          </p:nvSpPr>
          <p:spPr>
            <a:xfrm>
              <a:off x="3900690" y="2617652"/>
              <a:ext cx="28490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nti-ACTIN</a:t>
              </a: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100D91E9-C9AD-C142-BE64-E2972F5C9833}"/>
              </a:ext>
            </a:extLst>
          </p:cNvPr>
          <p:cNvSpPr txBox="1"/>
          <p:nvPr/>
        </p:nvSpPr>
        <p:spPr>
          <a:xfrm>
            <a:off x="959428" y="263003"/>
            <a:ext cx="4958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ile. 1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cropped western blots for Fig. 3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259327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32</Words>
  <Application>Microsoft Macintosh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gsan Kim</dc:creator>
  <cp:lastModifiedBy>Kangsan Kim</cp:lastModifiedBy>
  <cp:revision>4</cp:revision>
  <dcterms:created xsi:type="dcterms:W3CDTF">2021-07-19T20:04:00Z</dcterms:created>
  <dcterms:modified xsi:type="dcterms:W3CDTF">2021-08-10T16:11:30Z</dcterms:modified>
</cp:coreProperties>
</file>